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8" d="100"/>
          <a:sy n="78" d="100"/>
        </p:scale>
        <p:origin x="1500" y="-20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5908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181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9770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9822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3271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4055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9443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2054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780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8056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3494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9DB5D-2426-4A70-9EA8-8794857CB8F7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36527-9E35-44B2-881A-827B52CFA2A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5408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D618908F-8D1D-48D2-8964-A9BAB3851247}"/>
              </a:ext>
            </a:extLst>
          </p:cNvPr>
          <p:cNvSpPr/>
          <p:nvPr/>
        </p:nvSpPr>
        <p:spPr>
          <a:xfrm>
            <a:off x="227879" y="8947593"/>
            <a:ext cx="624549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. S2</a:t>
            </a:r>
            <a:r>
              <a:rPr lang="en-US" altLang="zh-CN" sz="1400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gulatory elements in pSjNR-S. Their positions relative to SjNR-S +1 start codon ATG are indicated. Vertical line points to the first base of each element.</a:t>
            </a:r>
            <a:endParaRPr lang="zh-CN" altLang="zh-CN" sz="1400" kern="10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13314A3-3272-4874-A5BE-CD7EBABC11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467" y="518028"/>
            <a:ext cx="6383065" cy="80535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4947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33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4</cp:revision>
  <dcterms:created xsi:type="dcterms:W3CDTF">2023-01-05T08:57:38Z</dcterms:created>
  <dcterms:modified xsi:type="dcterms:W3CDTF">2023-01-05T21:43:42Z</dcterms:modified>
</cp:coreProperties>
</file>